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14400213" cy="1800066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kaya Kitano" initials="TK" lastIdx="2" clrIdx="0">
    <p:extLst>
      <p:ext uri="{19B8F6BF-5375-455C-9EA6-DF929625EA0E}">
        <p15:presenceInfo xmlns:p15="http://schemas.microsoft.com/office/powerpoint/2012/main" userId="Takaya Kitan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1133" y="-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945943"/>
            <a:ext cx="12240181" cy="626689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9454516"/>
            <a:ext cx="10800160" cy="434599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964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17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958369"/>
            <a:ext cx="3105046" cy="1525473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958369"/>
            <a:ext cx="9135135" cy="1525473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9303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560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4487671"/>
            <a:ext cx="12420184" cy="7487774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2046282"/>
            <a:ext cx="12420184" cy="3937644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053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4791843"/>
            <a:ext cx="6120091" cy="114212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4791843"/>
            <a:ext cx="6120091" cy="114212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616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58373"/>
            <a:ext cx="12420184" cy="347929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4412664"/>
            <a:ext cx="6091964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6575242"/>
            <a:ext cx="6091964" cy="9671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4412664"/>
            <a:ext cx="6121966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6575242"/>
            <a:ext cx="6121966" cy="9671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0399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261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060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591766"/>
            <a:ext cx="7290108" cy="12792138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886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591766"/>
            <a:ext cx="7290108" cy="12792138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1009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958373"/>
            <a:ext cx="12420184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4791843"/>
            <a:ext cx="12420184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8F5D5-4065-4643-AC3D-4584C09AEAB1}" type="datetimeFigureOut">
              <a:rPr kumimoji="1" lang="ja-JP" altLang="en-US" smtClean="0"/>
              <a:t>2023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6683952"/>
            <a:ext cx="4860072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FC78C-1F8E-42A8-BFC0-994C33E207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841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5240" y="2039528"/>
            <a:ext cx="5648325" cy="394335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85555" y="1971502"/>
            <a:ext cx="5648325" cy="4181475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766218" y="960514"/>
            <a:ext cx="13145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he correlation between Brain Fog levels and ferritin values.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three months after onset of COVID-19)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2924522" y="2939064"/>
            <a:ext cx="439838" cy="3819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3237122F-B111-E9AA-A858-F483B882141D}"/>
              </a:ext>
            </a:extLst>
          </p:cNvPr>
          <p:cNvSpPr/>
          <p:nvPr/>
        </p:nvSpPr>
        <p:spPr>
          <a:xfrm>
            <a:off x="9974183" y="5860522"/>
            <a:ext cx="2166257" cy="4148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B74EA7-141C-695A-59CE-F2FA09E099D6}"/>
              </a:ext>
            </a:extLst>
          </p:cNvPr>
          <p:cNvSpPr txBox="1"/>
          <p:nvPr/>
        </p:nvSpPr>
        <p:spPr>
          <a:xfrm>
            <a:off x="7243321" y="5895804"/>
            <a:ext cx="1502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numbe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1F24126-1874-7A0D-7A05-BC9F6B0596A4}"/>
              </a:ext>
            </a:extLst>
          </p:cNvPr>
          <p:cNvSpPr txBox="1"/>
          <p:nvPr/>
        </p:nvSpPr>
        <p:spPr>
          <a:xfrm>
            <a:off x="8764720" y="5895804"/>
            <a:ext cx="500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3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766A0EA-36E8-41F4-FDB1-307FADF00710}"/>
              </a:ext>
            </a:extLst>
          </p:cNvPr>
          <p:cNvSpPr txBox="1"/>
          <p:nvPr/>
        </p:nvSpPr>
        <p:spPr>
          <a:xfrm>
            <a:off x="9789128" y="5895804"/>
            <a:ext cx="468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CC66DD8-4297-3BF1-C478-BD107CF2ABF6}"/>
              </a:ext>
            </a:extLst>
          </p:cNvPr>
          <p:cNvSpPr txBox="1"/>
          <p:nvPr/>
        </p:nvSpPr>
        <p:spPr>
          <a:xfrm>
            <a:off x="10736186" y="5895804"/>
            <a:ext cx="468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AC7C1C3-9C34-3ABC-8918-9514D55C3CBE}"/>
              </a:ext>
            </a:extLst>
          </p:cNvPr>
          <p:cNvSpPr txBox="1"/>
          <p:nvPr/>
        </p:nvSpPr>
        <p:spPr>
          <a:xfrm>
            <a:off x="11683243" y="5895804"/>
            <a:ext cx="468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60B9DB3-78E3-40FE-A66E-4D4342B163CF}"/>
              </a:ext>
            </a:extLst>
          </p:cNvPr>
          <p:cNvSpPr txBox="1"/>
          <p:nvPr/>
        </p:nvSpPr>
        <p:spPr>
          <a:xfrm>
            <a:off x="12676136" y="5895804"/>
            <a:ext cx="468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7EAD8FC-92E7-840E-08C6-7859E6F6FE87}"/>
              </a:ext>
            </a:extLst>
          </p:cNvPr>
          <p:cNvSpPr txBox="1"/>
          <p:nvPr/>
        </p:nvSpPr>
        <p:spPr>
          <a:xfrm>
            <a:off x="8885611" y="6275416"/>
            <a:ext cx="40930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rain Fog level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右大かっこ 3">
            <a:extLst>
              <a:ext uri="{FF2B5EF4-FFF2-40B4-BE49-F238E27FC236}">
                <a16:creationId xmlns:a16="http://schemas.microsoft.com/office/drawing/2014/main" id="{44100308-9805-867B-774B-1E5F6E7F8717}"/>
              </a:ext>
            </a:extLst>
          </p:cNvPr>
          <p:cNvSpPr/>
          <p:nvPr/>
        </p:nvSpPr>
        <p:spPr>
          <a:xfrm rot="16200000">
            <a:off x="4271203" y="862173"/>
            <a:ext cx="173956" cy="2354712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8CD8B28-B7A0-3913-7ACC-F161BC766F9E}"/>
              </a:ext>
            </a:extLst>
          </p:cNvPr>
          <p:cNvSpPr txBox="1"/>
          <p:nvPr/>
        </p:nvSpPr>
        <p:spPr>
          <a:xfrm>
            <a:off x="3750466" y="1613995"/>
            <a:ext cx="12154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 = 0.14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571AFE2-65FD-2836-A474-5D3A4820DC01}"/>
              </a:ext>
            </a:extLst>
          </p:cNvPr>
          <p:cNvSpPr txBox="1"/>
          <p:nvPr/>
        </p:nvSpPr>
        <p:spPr>
          <a:xfrm>
            <a:off x="12151330" y="2529334"/>
            <a:ext cx="10668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lang="en-US" altLang="ja-JP" sz="16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0.001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8AF32E2-96BF-ECE2-7375-A30A715C4955}"/>
              </a:ext>
            </a:extLst>
          </p:cNvPr>
          <p:cNvSpPr txBox="1"/>
          <p:nvPr/>
        </p:nvSpPr>
        <p:spPr>
          <a:xfrm>
            <a:off x="1062216" y="1530335"/>
            <a:ext cx="540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(a)</a:t>
            </a:r>
            <a:endParaRPr kumimoji="1"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313C121-7AAF-A85B-AF61-722B1EAF5D73}"/>
              </a:ext>
            </a:extLst>
          </p:cNvPr>
          <p:cNvSpPr txBox="1"/>
          <p:nvPr/>
        </p:nvSpPr>
        <p:spPr>
          <a:xfrm>
            <a:off x="7145117" y="1530335"/>
            <a:ext cx="540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(b)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ADBE66B-C941-4C5D-42F3-3A4016FBD3EF}"/>
              </a:ext>
            </a:extLst>
          </p:cNvPr>
          <p:cNvSpPr txBox="1"/>
          <p:nvPr/>
        </p:nvSpPr>
        <p:spPr>
          <a:xfrm>
            <a:off x="766218" y="7120539"/>
            <a:ext cx="12195544" cy="1668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 Mann–Whitney U test was performed. Peak ferritin levels did not </a:t>
            </a:r>
            <a:r>
              <a:rPr lang="en-US" altLang="ja-JP" sz="18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hange significantly between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two groups (p=0.14). (b)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eak ferritin levels in each Brain Fog level are expressed in a box plot.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Linear Regression fitted a dashed line between ferritin peak values and Brain Fog levels (p=0.001).</a:t>
            </a:r>
            <a:endParaRPr lang="ja-JP" altLang="ja-JP" sz="18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1100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87</TotalTime>
  <Words>109</Words>
  <Application>Microsoft Office PowerPoint</Application>
  <PresentationFormat>ユーザー設定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my AnnMcCoy</dc:creator>
  <cp:lastModifiedBy>石倉　照之</cp:lastModifiedBy>
  <cp:revision>139</cp:revision>
  <cp:lastPrinted>2023-02-24T08:03:20Z</cp:lastPrinted>
  <dcterms:created xsi:type="dcterms:W3CDTF">2022-05-06T09:53:03Z</dcterms:created>
  <dcterms:modified xsi:type="dcterms:W3CDTF">2023-07-11T01:20:03Z</dcterms:modified>
</cp:coreProperties>
</file>